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2670" y="-72"/>
      </p:cViewPr>
      <p:guideLst>
        <p:guide orient="horz" pos="2880"/>
        <p:guide pos="102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R&#233;sultats%20M&#233;lanie\article%20in%20vivo%20M&#233;lanie\fichiers%20pour%20soumettre\fichiers%20donn&#233;es\R&#233;sultats%20WB%2002.09.2015%2008082016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F:\R&#233;sultats%20M&#233;lanie\article%20in%20vivo%20M&#233;lanie\fichiers%20pour%20soumettre\fichiers%20donn&#233;es\R&#233;sultats%20WB%2002.09.2015%200808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90261085506932"/>
          <c:y val="5.0925925925925923E-2"/>
          <c:w val="0.78950963008687924"/>
          <c:h val="0.73519320501603969"/>
        </c:manualLayout>
      </c:layout>
      <c:barChart>
        <c:barDir val="col"/>
        <c:grouping val="clustered"/>
        <c:varyColors val="0"/>
        <c:ser>
          <c:idx val="0"/>
          <c:order val="0"/>
          <c:tx>
            <c:v>GLUR3/beta-tubulin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9050"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SNAP25!$N$2,SNAP25!$N$6,SNAP25!$N$10,SNAP25!$N$16)</c:f>
                <c:numCache>
                  <c:formatCode>General</c:formatCode>
                  <c:ptCount val="4"/>
                  <c:pt idx="0">
                    <c:v>8.1614159420512227</c:v>
                  </c:pt>
                  <c:pt idx="1">
                    <c:v>13.153177363118322</c:v>
                  </c:pt>
                  <c:pt idx="2">
                    <c:v>2.8996421859863828</c:v>
                  </c:pt>
                  <c:pt idx="3">
                    <c:v>10.802049581130033</c:v>
                  </c:pt>
                </c:numCache>
              </c:numRef>
            </c:plus>
            <c:minus>
              <c:numRef>
                <c:f>(SNAP25!$N$2,SNAP25!$N$6,SNAP25!$N$10,SNAP25!$N$16)</c:f>
                <c:numCache>
                  <c:formatCode>General</c:formatCode>
                  <c:ptCount val="4"/>
                  <c:pt idx="0">
                    <c:v>8.1614159420512227</c:v>
                  </c:pt>
                  <c:pt idx="1">
                    <c:v>13.153177363118322</c:v>
                  </c:pt>
                  <c:pt idx="2">
                    <c:v>2.8996421859863828</c:v>
                  </c:pt>
                  <c:pt idx="3">
                    <c:v>10.80204958113003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SNAP25!$M$2,SNAP25!$M$6,SNAP25!$M$10,SNAP25!$M$16)</c:f>
              <c:numCache>
                <c:formatCode>General</c:formatCode>
                <c:ptCount val="4"/>
                <c:pt idx="0">
                  <c:v>100</c:v>
                </c:pt>
                <c:pt idx="1">
                  <c:v>105.34169869116157</c:v>
                </c:pt>
                <c:pt idx="2">
                  <c:v>96.149976045552535</c:v>
                </c:pt>
                <c:pt idx="3">
                  <c:v>107.898844194039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311232"/>
        <c:axId val="81312768"/>
      </c:barChart>
      <c:catAx>
        <c:axId val="8131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81312768"/>
        <c:crosses val="autoZero"/>
        <c:auto val="1"/>
        <c:lblAlgn val="ctr"/>
        <c:lblOffset val="100"/>
        <c:noMultiLvlLbl val="0"/>
      </c:catAx>
      <c:valAx>
        <c:axId val="813127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fr-FR" sz="1400" b="1" dirty="0">
                    <a:latin typeface="Arial" pitchFamily="34" charset="0"/>
                    <a:cs typeface="Arial" pitchFamily="34" charset="0"/>
                  </a:rPr>
                  <a:t>SNAP25/</a:t>
                </a:r>
                <a:r>
                  <a:rPr lang="el-GR" sz="1400" b="1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fr-FR" sz="14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fr-FR" sz="1400" b="1" dirty="0" err="1" smtClean="0">
                    <a:latin typeface="Arial" pitchFamily="34" charset="0"/>
                    <a:cs typeface="Arial" pitchFamily="34" charset="0"/>
                  </a:rPr>
                  <a:t>tubulin</a:t>
                </a:r>
                <a:r>
                  <a:rPr lang="fr-FR" sz="1400" b="1" dirty="0" smtClean="0">
                    <a:latin typeface="Arial" pitchFamily="34" charset="0"/>
                    <a:cs typeface="Arial" pitchFamily="34" charset="0"/>
                  </a:rPr>
                  <a:t/>
                </a:r>
                <a:br>
                  <a:rPr lang="fr-FR" sz="1400" b="1" dirty="0" smtClean="0">
                    <a:latin typeface="Arial" pitchFamily="34" charset="0"/>
                    <a:cs typeface="Arial" pitchFamily="34" charset="0"/>
                  </a:rPr>
                </a:br>
                <a:r>
                  <a:rPr lang="fr-FR" sz="1400" b="1" dirty="0" smtClean="0">
                    <a:latin typeface="Arial" pitchFamily="34" charset="0"/>
                    <a:cs typeface="Arial" pitchFamily="34" charset="0"/>
                  </a:rPr>
                  <a:t>(% of the control)</a:t>
                </a:r>
                <a:endParaRPr lang="fr-FR" sz="1400" b="1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81311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33662502679188"/>
          <c:y val="5.0925925925925923E-2"/>
          <c:w val="0.74203221720049883"/>
          <c:h val="0.73519320501603969"/>
        </c:manualLayout>
      </c:layout>
      <c:barChart>
        <c:barDir val="col"/>
        <c:grouping val="clustered"/>
        <c:varyColors val="0"/>
        <c:ser>
          <c:idx val="0"/>
          <c:order val="0"/>
          <c:tx>
            <c:v>GLUR3/beta-tubulin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SNAP25!$N$27,SNAP25!$N$31,SNAP25!$N$35,SNAP25!$N$41)</c:f>
                <c:numCache>
                  <c:formatCode>General</c:formatCode>
                  <c:ptCount val="4"/>
                  <c:pt idx="0">
                    <c:v>4.1193353485383799</c:v>
                  </c:pt>
                  <c:pt idx="1">
                    <c:v>10.390885939610135</c:v>
                  </c:pt>
                  <c:pt idx="2">
                    <c:v>16.059928660122207</c:v>
                  </c:pt>
                  <c:pt idx="3">
                    <c:v>3.1891372739550037</c:v>
                  </c:pt>
                </c:numCache>
              </c:numRef>
            </c:plus>
            <c:minus>
              <c:numRef>
                <c:f>(SNAP25!$N$27,SNAP25!$N$31,SNAP25!$N$35,SNAP25!$N$41)</c:f>
                <c:numCache>
                  <c:formatCode>General</c:formatCode>
                  <c:ptCount val="4"/>
                  <c:pt idx="0">
                    <c:v>4.1193353485383799</c:v>
                  </c:pt>
                  <c:pt idx="1">
                    <c:v>10.390885939610135</c:v>
                  </c:pt>
                  <c:pt idx="2">
                    <c:v>16.059928660122207</c:v>
                  </c:pt>
                  <c:pt idx="3">
                    <c:v>3.1891372739550037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SNAP25!$M$27,SNAP25!$M$31,SNAP25!$M$35,SNAP25!$M$41)</c:f>
              <c:numCache>
                <c:formatCode>General</c:formatCode>
                <c:ptCount val="4"/>
                <c:pt idx="0">
                  <c:v>100</c:v>
                </c:pt>
                <c:pt idx="1">
                  <c:v>122.3697818372159</c:v>
                </c:pt>
                <c:pt idx="2">
                  <c:v>131.73013012779083</c:v>
                </c:pt>
                <c:pt idx="3">
                  <c:v>96.0384370735105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345152"/>
        <c:axId val="81367424"/>
      </c:barChart>
      <c:catAx>
        <c:axId val="81345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81367424"/>
        <c:crosses val="autoZero"/>
        <c:auto val="1"/>
        <c:lblAlgn val="ctr"/>
        <c:lblOffset val="100"/>
        <c:noMultiLvlLbl val="0"/>
      </c:catAx>
      <c:valAx>
        <c:axId val="81367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fr-FR" sz="1400" b="1" i="0" baseline="0" dirty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NAP25/</a:t>
                </a:r>
                <a:r>
                  <a:rPr lang="el-GR" sz="1400" b="1" i="0" baseline="0" dirty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fr-FR" sz="1400" b="1" i="0" baseline="0" dirty="0" smtClean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fr-FR" sz="1400" b="1" i="0" baseline="0" dirty="0" err="1" smtClean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ubulin</a:t>
                </a:r>
                <a:r>
                  <a:rPr lang="fr-FR" sz="1400" b="1" i="0" baseline="0" dirty="0" smtClean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/>
                </a:r>
                <a:br>
                  <a:rPr lang="fr-FR" sz="1400" b="1" i="0" baseline="0" dirty="0" smtClean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</a:br>
                <a:r>
                  <a:rPr lang="fr-FR" sz="1400" b="1" i="0" baseline="0" dirty="0" smtClean="0">
                    <a:solidFill>
                      <a:sysClr val="windowText" lastClr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(% of the control)</a:t>
                </a:r>
                <a:endParaRPr lang="fr-FR" sz="1400" b="1" dirty="0">
                  <a:solidFill>
                    <a:sysClr val="windowText" lastClr="000000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81345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0795</cdr:x>
      <cdr:y>0.88365</cdr:y>
    </cdr:from>
    <cdr:to>
      <cdr:x>0.43711</cdr:x>
      <cdr:y>0.88365</cdr:y>
    </cdr:to>
    <cdr:cxnSp macro="">
      <cdr:nvCxnSpPr>
        <cdr:cNvPr id="3" name="Connecteur droit 2"/>
        <cdr:cNvCxnSpPr/>
      </cdr:nvCxnSpPr>
      <cdr:spPr>
        <a:xfrm xmlns:a="http://schemas.openxmlformats.org/drawingml/2006/main">
          <a:off x="1014127" y="2777537"/>
          <a:ext cx="1117568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1736</cdr:x>
      <cdr:y>0.88178</cdr:y>
    </cdr:from>
    <cdr:to>
      <cdr:x>0.84652</cdr:x>
      <cdr:y>0.88178</cdr:y>
    </cdr:to>
    <cdr:cxnSp macro="">
      <cdr:nvCxnSpPr>
        <cdr:cNvPr id="4" name="Connecteur droit 3"/>
        <cdr:cNvCxnSpPr/>
      </cdr:nvCxnSpPr>
      <cdr:spPr>
        <a:xfrm xmlns:a="http://schemas.openxmlformats.org/drawingml/2006/main">
          <a:off x="3010741" y="2771658"/>
          <a:ext cx="1117567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0625</cdr:x>
      <cdr:y>0.88542</cdr:y>
    </cdr:from>
    <cdr:to>
      <cdr:x>0.42083</cdr:x>
      <cdr:y>0.98612</cdr:y>
    </cdr:to>
    <cdr:sp macro="" textlink="">
      <cdr:nvSpPr>
        <cdr:cNvPr id="5" name="ZoneTexte 4"/>
        <cdr:cNvSpPr txBox="1"/>
      </cdr:nvSpPr>
      <cdr:spPr>
        <a:xfrm xmlns:a="http://schemas.openxmlformats.org/drawingml/2006/main">
          <a:off x="942975" y="2428872"/>
          <a:ext cx="981060" cy="2762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fr-FR" sz="1400">
              <a:latin typeface="Arial" pitchFamily="34" charset="0"/>
              <a:cs typeface="Arial" pitchFamily="34" charset="0"/>
            </a:rPr>
            <a:t>OLE</a:t>
          </a:r>
        </a:p>
      </cdr:txBody>
    </cdr:sp>
  </cdr:relSizeAnchor>
  <cdr:relSizeAnchor xmlns:cdr="http://schemas.openxmlformats.org/drawingml/2006/chartDrawing">
    <cdr:from>
      <cdr:x>0.62152</cdr:x>
      <cdr:y>0.8831</cdr:y>
    </cdr:from>
    <cdr:to>
      <cdr:x>0.83611</cdr:x>
      <cdr:y>0.98379</cdr:y>
    </cdr:to>
    <cdr:sp macro="" textlink="">
      <cdr:nvSpPr>
        <cdr:cNvPr id="6" name="ZoneTexte 1"/>
        <cdr:cNvSpPr txBox="1"/>
      </cdr:nvSpPr>
      <cdr:spPr>
        <a:xfrm xmlns:a="http://schemas.openxmlformats.org/drawingml/2006/main">
          <a:off x="2841605" y="2422529"/>
          <a:ext cx="981105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400">
              <a:latin typeface="Arial" pitchFamily="34" charset="0"/>
              <a:cs typeface="Arial" pitchFamily="34" charset="0"/>
            </a:rPr>
            <a:t>ARA</a:t>
          </a:r>
        </a:p>
      </cdr:txBody>
    </cdr:sp>
  </cdr:relSizeAnchor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0209</cdr:x>
      <cdr:y>0.87975</cdr:y>
    </cdr:from>
    <cdr:to>
      <cdr:x>0.43125</cdr:x>
      <cdr:y>0.87975</cdr:y>
    </cdr:to>
    <cdr:cxnSp macro="">
      <cdr:nvCxnSpPr>
        <cdr:cNvPr id="3" name="Connecteur droit 2"/>
        <cdr:cNvCxnSpPr/>
      </cdr:nvCxnSpPr>
      <cdr:spPr>
        <a:xfrm xmlns:a="http://schemas.openxmlformats.org/drawingml/2006/main">
          <a:off x="1064474" y="3058558"/>
          <a:ext cx="120706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1736</cdr:x>
      <cdr:y>0.88091</cdr:y>
    </cdr:from>
    <cdr:to>
      <cdr:x>0.84652</cdr:x>
      <cdr:y>0.88091</cdr:y>
    </cdr:to>
    <cdr:cxnSp macro="">
      <cdr:nvCxnSpPr>
        <cdr:cNvPr id="4" name="Connecteur droit 3"/>
        <cdr:cNvCxnSpPr/>
      </cdr:nvCxnSpPr>
      <cdr:spPr>
        <a:xfrm xmlns:a="http://schemas.openxmlformats.org/drawingml/2006/main">
          <a:off x="3251836" y="3062591"/>
          <a:ext cx="120706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0625</cdr:x>
      <cdr:y>0.88542</cdr:y>
    </cdr:from>
    <cdr:to>
      <cdr:x>0.42083</cdr:x>
      <cdr:y>0.98612</cdr:y>
    </cdr:to>
    <cdr:sp macro="" textlink="">
      <cdr:nvSpPr>
        <cdr:cNvPr id="5" name="ZoneTexte 4"/>
        <cdr:cNvSpPr txBox="1"/>
      </cdr:nvSpPr>
      <cdr:spPr>
        <a:xfrm xmlns:a="http://schemas.openxmlformats.org/drawingml/2006/main">
          <a:off x="942975" y="2428872"/>
          <a:ext cx="981060" cy="2762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fr-FR" sz="1400" b="1">
              <a:latin typeface="Arial" pitchFamily="34" charset="0"/>
              <a:cs typeface="Arial" pitchFamily="34" charset="0"/>
            </a:rPr>
            <a:t>contrôle</a:t>
          </a:r>
        </a:p>
      </cdr:txBody>
    </cdr:sp>
  </cdr:relSizeAnchor>
  <cdr:relSizeAnchor xmlns:cdr="http://schemas.openxmlformats.org/drawingml/2006/chartDrawing">
    <cdr:from>
      <cdr:x>0.62152</cdr:x>
      <cdr:y>0.8831</cdr:y>
    </cdr:from>
    <cdr:to>
      <cdr:x>0.83611</cdr:x>
      <cdr:y>0.98379</cdr:y>
    </cdr:to>
    <cdr:sp macro="" textlink="">
      <cdr:nvSpPr>
        <cdr:cNvPr id="6" name="ZoneTexte 1"/>
        <cdr:cNvSpPr txBox="1"/>
      </cdr:nvSpPr>
      <cdr:spPr>
        <a:xfrm xmlns:a="http://schemas.openxmlformats.org/drawingml/2006/main">
          <a:off x="2841605" y="2422529"/>
          <a:ext cx="981105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400" b="1">
              <a:latin typeface="Arial" pitchFamily="34" charset="0"/>
              <a:cs typeface="Arial" pitchFamily="34" charset="0"/>
            </a:rPr>
            <a:t>ARA</a:t>
          </a:r>
        </a:p>
      </cdr:txBody>
    </cdr:sp>
  </cdr:relSizeAnchor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5866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6126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609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3992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7608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6293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3046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9140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7199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0963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990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707F3-CAD9-475D-9844-C24D031A18A4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61B23-1D34-414C-B4DC-0171E4B02CB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289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9526166"/>
              </p:ext>
            </p:extLst>
          </p:nvPr>
        </p:nvGraphicFramePr>
        <p:xfrm>
          <a:off x="806370" y="755576"/>
          <a:ext cx="5358934" cy="36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54992" y="6115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043938"/>
              </p:ext>
            </p:extLst>
          </p:nvPr>
        </p:nvGraphicFramePr>
        <p:xfrm>
          <a:off x="548680" y="4572000"/>
          <a:ext cx="5699374" cy="38366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454992" y="43873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0" y="0"/>
            <a:ext cx="34614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8, Thomas MH </a:t>
            </a:r>
            <a:r>
              <a:rPr lang="fr-FR" sz="1200" i="1" dirty="0" smtClean="0"/>
              <a:t>et al.</a:t>
            </a:r>
            <a:r>
              <a:rPr lang="fr-FR" sz="1200" dirty="0" smtClean="0"/>
              <a:t>,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4131350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3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HU de Nanc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LIVIER Jean-luc</dc:creator>
  <cp:lastModifiedBy>Jean Luc OLIVIER</cp:lastModifiedBy>
  <cp:revision>5</cp:revision>
  <dcterms:created xsi:type="dcterms:W3CDTF">2016-08-08T13:54:55Z</dcterms:created>
  <dcterms:modified xsi:type="dcterms:W3CDTF">2017-07-28T18:51:37Z</dcterms:modified>
</cp:coreProperties>
</file>